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4831D-749D-42F1-ADC4-E0F2596D8B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32112-49C0-4F1B-8EBC-9720FA2451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8EC90C-7F4D-4005-AA97-011D085D02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F69A7E-BEA5-4CE6-AFA8-0E364112BC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4FFBD-3B6C-4DFD-A665-AEE8B5723E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8B067-917E-4DE6-AAA4-A99768467E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9E41B-4BF2-40A6-B12B-8CFA7B94E9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7A407-8451-4C42-A97E-7E3C3F4786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35141-2666-4185-B020-933CFFFFCA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7E634-EC0B-4E41-8343-1FE9718273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08DFA-DC06-4049-A712-E01B7ED3B1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7E80A-206F-4CC6-BD92-F383060390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0C56DE-018B-4A4C-8EB3-85E63DD418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149760" y="3505320"/>
            <a:ext cx="1584360" cy="64260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edlin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8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 80% R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2201400" y="2514600"/>
            <a:ext cx="991440" cy="368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duc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1740600" y="3886200"/>
            <a:ext cx="14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n-induc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2425680" y="5029200"/>
            <a:ext cx="181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bsolute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3489480" y="3505320"/>
            <a:ext cx="1447560" cy="64260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hallenging str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5630400" y="3657600"/>
            <a:ext cx="1143720" cy="368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cove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" name="AutoShape 10"/>
          <p:cNvCxnSpPr>
            <a:endCxn id="42" idx="1"/>
          </p:cNvCxnSpPr>
          <p:nvPr/>
        </p:nvCxnSpPr>
        <p:spPr>
          <a:xfrm flipV="1">
            <a:off x="974880" y="2698560"/>
            <a:ext cx="1226880" cy="888120"/>
          </a:xfrm>
          <a:prstGeom prst="straightConnector1">
            <a:avLst/>
          </a:prstGeom>
          <a:ln w="9360">
            <a:solidFill>
              <a:srgbClr val="333399"/>
            </a:solidFill>
            <a:miter/>
            <a:tailEnd len="med" type="arrow" w="med"/>
          </a:ln>
        </p:spPr>
      </p:cxnSp>
      <p:cxnSp>
        <p:nvCxnSpPr>
          <p:cNvPr id="48" name="AutoShape 11"/>
          <p:cNvCxnSpPr>
            <a:stCxn id="42" idx="3"/>
            <a:endCxn id="45" idx="0"/>
          </p:cNvCxnSpPr>
          <p:nvPr/>
        </p:nvCxnSpPr>
        <p:spPr>
          <a:xfrm>
            <a:off x="3192840" y="2698560"/>
            <a:ext cx="1020600" cy="807120"/>
          </a:xfrm>
          <a:prstGeom prst="straightConnector1">
            <a:avLst/>
          </a:prstGeom>
          <a:ln w="9360">
            <a:solidFill>
              <a:srgbClr val="333399"/>
            </a:solidFill>
            <a:miter/>
            <a:tailEnd len="med" type="arrow" w="med"/>
          </a:ln>
        </p:spPr>
      </p:cxnSp>
      <p:cxnSp>
        <p:nvCxnSpPr>
          <p:cNvPr id="49" name="AutoShape 12"/>
          <p:cNvCxnSpPr>
            <a:stCxn id="41" idx="3"/>
            <a:endCxn id="45" idx="1"/>
          </p:cNvCxnSpPr>
          <p:nvPr/>
        </p:nvCxnSpPr>
        <p:spPr>
          <a:xfrm>
            <a:off x="1734120" y="3826440"/>
            <a:ext cx="1755720" cy="360"/>
          </a:xfrm>
          <a:prstGeom prst="straightConnector1">
            <a:avLst/>
          </a:prstGeom>
          <a:ln w="9360">
            <a:solidFill>
              <a:srgbClr val="800000"/>
            </a:solidFill>
            <a:miter/>
            <a:tailEnd len="med" type="arrow" w="med"/>
          </a:ln>
        </p:spPr>
      </p:cxnSp>
      <p:cxnSp>
        <p:nvCxnSpPr>
          <p:cNvPr id="50" name="AutoShape 14"/>
          <p:cNvCxnSpPr>
            <a:stCxn id="41" idx="2"/>
            <a:endCxn id="46" idx="2"/>
          </p:cNvCxnSpPr>
          <p:nvPr/>
        </p:nvCxnSpPr>
        <p:spPr>
          <a:xfrm flipH="1" flipV="1" rot="5400000">
            <a:off x="3510720" y="1456560"/>
            <a:ext cx="122400" cy="5260680"/>
          </a:xfrm>
          <a:prstGeom prst="bentConnector3">
            <a:avLst>
              <a:gd name="adj1" fmla="val -189675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AutoShape 15"/>
          <p:cNvCxnSpPr/>
          <p:nvPr/>
        </p:nvCxnSpPr>
        <p:spPr>
          <a:xfrm>
            <a:off x="4936680" y="3733920"/>
            <a:ext cx="686520" cy="16560"/>
          </a:xfrm>
          <a:prstGeom prst="straightConnector1">
            <a:avLst/>
          </a:prstGeom>
          <a:ln w="9360">
            <a:solidFill>
              <a:srgbClr val="333399"/>
            </a:solidFill>
            <a:miter/>
            <a:tailEnd len="med" type="arrow" w="med"/>
          </a:ln>
        </p:spPr>
      </p:cxnSp>
      <p:cxnSp>
        <p:nvCxnSpPr>
          <p:cNvPr id="52" name="AutoShape 17"/>
          <p:cNvCxnSpPr/>
          <p:nvPr/>
        </p:nvCxnSpPr>
        <p:spPr>
          <a:xfrm>
            <a:off x="4936680" y="3946680"/>
            <a:ext cx="686520" cy="16560"/>
          </a:xfrm>
          <a:prstGeom prst="straightConnector1">
            <a:avLst/>
          </a:prstGeom>
          <a:ln w="9360">
            <a:solidFill>
              <a:srgbClr val="800000"/>
            </a:solidFill>
            <a:miter/>
            <a:tailEnd len="med" type="arrow" w="med"/>
          </a:ln>
        </p:spPr>
      </p:cxnSp>
      <p:sp>
        <p:nvSpPr>
          <p:cNvPr id="53" name="Rectangle 18"/>
          <p:cNvSpPr/>
          <p:nvPr/>
        </p:nvSpPr>
        <p:spPr>
          <a:xfrm>
            <a:off x="457200" y="5912640"/>
            <a:ext cx="5943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3. General protocol to study the acclimation response of sunflower seedlings and plants. Induced: seedlings or plants subjected to sub-lethal acclimation stress treatment and then immediately transferred to the challenging (severe) stress. Non-induced: seedlings grown at normal growth conditions at 30 °C and then exposed to the severe stress. Absolute control: seedlings maintained at 30 °C throughout the experiment. Recovery: after the stress imposition, seedlings were allowed to recover under normal growth condi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00:35:20Z</dcterms:created>
  <dc:creator>skmuthappa</dc:creator>
  <dc:description/>
  <dc:language>en-US</dc:language>
  <cp:lastModifiedBy>Senthil-Kumar Muthappa</cp:lastModifiedBy>
  <dcterms:modified xsi:type="dcterms:W3CDTF">2016-02-15T05:24:46Z</dcterms:modified>
  <cp:revision>14</cp:revision>
  <dc:subject/>
  <dc:title>Slide 1</dc:title>
</cp:coreProperties>
</file>